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7" d="100"/>
          <a:sy n="87" d="100"/>
        </p:scale>
        <p:origin x="61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732F3-CCFC-4A84-82B2-325854705AC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E62E8-E7F5-4DEE-8A18-148C636AE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891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732F3-CCFC-4A84-82B2-325854705AC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E62E8-E7F5-4DEE-8A18-148C636AE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0800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732F3-CCFC-4A84-82B2-325854705AC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E62E8-E7F5-4DEE-8A18-148C636AE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062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732F3-CCFC-4A84-82B2-325854705AC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E62E8-E7F5-4DEE-8A18-148C636AE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474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732F3-CCFC-4A84-82B2-325854705AC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E62E8-E7F5-4DEE-8A18-148C636AE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7786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732F3-CCFC-4A84-82B2-325854705AC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E62E8-E7F5-4DEE-8A18-148C636AE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607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732F3-CCFC-4A84-82B2-325854705AC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E62E8-E7F5-4DEE-8A18-148C636AE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3431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732F3-CCFC-4A84-82B2-325854705AC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E62E8-E7F5-4DEE-8A18-148C636AE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528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732F3-CCFC-4A84-82B2-325854705AC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E62E8-E7F5-4DEE-8A18-148C636AE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576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732F3-CCFC-4A84-82B2-325854705AC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E62E8-E7F5-4DEE-8A18-148C636AE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723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732F3-CCFC-4A84-82B2-325854705AC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E62E8-E7F5-4DEE-8A18-148C636AE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1622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B732F3-CCFC-4A84-82B2-325854705AC5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2E62E8-E7F5-4DEE-8A18-148C636AE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3099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94107" y="6090285"/>
            <a:ext cx="1177480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/>
              <a:t>Figure </a:t>
            </a:r>
            <a:r>
              <a:rPr lang="en-US" smtClean="0"/>
              <a:t>S2. </a:t>
            </a:r>
            <a:r>
              <a:rPr lang="en-US" dirty="0" smtClean="0"/>
              <a:t>Graphs showing the relationship between the number of SNPs scored and the number of </a:t>
            </a:r>
            <a:r>
              <a:rPr lang="en-US" dirty="0" err="1" smtClean="0"/>
              <a:t>multilocus</a:t>
            </a:r>
            <a:r>
              <a:rPr lang="en-US" dirty="0" smtClean="0"/>
              <a:t> genotypes identified when using subsets of 100 (A), 200 (B), 500 (C) and 1000 (D) SNPs, and the full set of 3002 SNPs (E). </a:t>
            </a:r>
          </a:p>
          <a:p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7183" y="605711"/>
            <a:ext cx="2716530" cy="253746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7113" y="628571"/>
            <a:ext cx="2727960" cy="25146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88483" y="624682"/>
            <a:ext cx="2712720" cy="25222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1638" y="3394631"/>
            <a:ext cx="2731770" cy="252603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1133" y="3394631"/>
            <a:ext cx="2716530" cy="253365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828925" y="1981200"/>
            <a:ext cx="8567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100 SNPs</a:t>
            </a:r>
            <a:endParaRPr lang="en-US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6078855" y="1981200"/>
            <a:ext cx="8567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</a:t>
            </a:r>
            <a:r>
              <a:rPr lang="en-US" sz="1400" dirty="0" smtClean="0"/>
              <a:t>00 SNPs</a:t>
            </a:r>
            <a:endParaRPr 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9478739" y="1981200"/>
            <a:ext cx="8567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500 SNPs</a:t>
            </a:r>
            <a:endParaRPr lang="en-US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3880608" y="4657646"/>
            <a:ext cx="9480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1000 SNPs</a:t>
            </a:r>
            <a:endParaRPr lang="en-US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7400372" y="4657646"/>
            <a:ext cx="9480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3002 SNPs</a:t>
            </a:r>
            <a:endParaRPr lang="en-US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1571625" y="37322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</a:t>
            </a:r>
            <a:endParaRPr lang="en-US" sz="1400" dirty="0"/>
          </a:p>
        </p:txBody>
      </p:sp>
      <p:sp>
        <p:nvSpPr>
          <p:cNvPr id="17" name="TextBox 16"/>
          <p:cNvSpPr txBox="1"/>
          <p:nvPr/>
        </p:nvSpPr>
        <p:spPr>
          <a:xfrm>
            <a:off x="4838700" y="37322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B</a:t>
            </a:r>
            <a:endParaRPr lang="en-US" sz="1400" dirty="0"/>
          </a:p>
        </p:txBody>
      </p:sp>
      <p:sp>
        <p:nvSpPr>
          <p:cNvPr id="18" name="TextBox 17"/>
          <p:cNvSpPr txBox="1"/>
          <p:nvPr/>
        </p:nvSpPr>
        <p:spPr>
          <a:xfrm>
            <a:off x="8029575" y="37322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</a:t>
            </a:r>
            <a:endParaRPr lang="en-US" sz="1400" dirty="0"/>
          </a:p>
        </p:txBody>
      </p:sp>
      <p:sp>
        <p:nvSpPr>
          <p:cNvPr id="19" name="TextBox 18"/>
          <p:cNvSpPr txBox="1"/>
          <p:nvPr/>
        </p:nvSpPr>
        <p:spPr>
          <a:xfrm>
            <a:off x="2924175" y="3230722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D</a:t>
            </a:r>
            <a:endParaRPr lang="en-US" sz="1400" dirty="0"/>
          </a:p>
        </p:txBody>
      </p:sp>
      <p:sp>
        <p:nvSpPr>
          <p:cNvPr id="20" name="TextBox 19"/>
          <p:cNvSpPr txBox="1"/>
          <p:nvPr/>
        </p:nvSpPr>
        <p:spPr>
          <a:xfrm>
            <a:off x="6524625" y="3230722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E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858575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</TotalTime>
  <Words>68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Franklin College - University of Georg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rien M. Devos</dc:creator>
  <cp:lastModifiedBy>Katrien M. Devos</cp:lastModifiedBy>
  <cp:revision>12</cp:revision>
  <dcterms:created xsi:type="dcterms:W3CDTF">2019-07-25T23:54:53Z</dcterms:created>
  <dcterms:modified xsi:type="dcterms:W3CDTF">2020-02-08T16:41:47Z</dcterms:modified>
</cp:coreProperties>
</file>